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75450" cy="99075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4491C7-018D-4635-8AA7-B1739012946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EB7301-E50F-4A22-939B-B1C762E4FB6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C84B2C-ED15-4B28-8B4E-56FC7A29364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0FA220-4066-42B8-B2C3-9C4C8DBC444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451314-36A1-4AE1-8B76-4CF9D25F6CD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3FD8B5-BFFE-4D50-84D2-99F87ADE6F9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3036B3-F923-4BEE-842E-9AE32F525A3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F2BA2B-280D-424D-8D17-BCED2AF6EB0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24E24D-3B8A-4897-8D5A-09CCD3D18EF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219988-9249-4A53-8115-6D595F604EB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945F0F-8982-4185-9320-31E9C4A8B18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BCE72C-3855-4058-A323-230492705D5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EAE637E-84B5-4D6B-A811-EA7E5E71F796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509760" y="2759040"/>
            <a:ext cx="8097840" cy="28728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509760" y="3305160"/>
            <a:ext cx="8097840" cy="28728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509760" y="3857760"/>
            <a:ext cx="8097840" cy="28728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509760" y="2216160"/>
            <a:ext cx="8097840" cy="28728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6244920" y="223668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9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7644960" y="223668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23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4977720" y="2236680"/>
            <a:ext cx="406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800" spc="-1" strike="noStrike">
                <a:solidFill>
                  <a:srgbClr val="000000"/>
                </a:solidFill>
                <a:latin typeface="Arial"/>
              </a:rPr>
              <a:t>Age</a:t>
            </a:r>
            <a:r>
              <a:rPr b="1" lang="ja-JP" sz="800" spc="-1" strike="noStrike" baseline="30000">
                <a:solidFill>
                  <a:srgbClr val="000000"/>
                </a:solidFill>
                <a:latin typeface="Arial"/>
              </a:rPr>
              <a:t>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4397760" y="2236680"/>
            <a:ext cx="537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Gende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2577600" y="2112840"/>
            <a:ext cx="912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ollection dat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727200" y="2112840"/>
            <a:ext cx="829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800" spc="-1" strike="noStrike">
                <a:solidFill>
                  <a:srgbClr val="000000"/>
                </a:solidFill>
                <a:latin typeface="Arial"/>
              </a:rPr>
              <a:t>Virus strain</a:t>
            </a:r>
            <a:r>
              <a:rPr b="1" lang="ja-JP" sz="800" spc="-1" strike="noStrike" baseline="30000">
                <a:solidFill>
                  <a:srgbClr val="000000"/>
                </a:solidFill>
                <a:latin typeface="Arial"/>
              </a:rPr>
              <a:t>a,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725760" y="4165560"/>
            <a:ext cx="1972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Other H5N1 viruses isolated in Egyp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6282000" y="4165560"/>
            <a:ext cx="25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Q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7681680" y="4165560"/>
            <a:ext cx="249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4486320" y="1932120"/>
            <a:ext cx="758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Patient dat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5" name=""/>
          <p:cNvGrpSpPr/>
          <p:nvPr/>
        </p:nvGrpSpPr>
        <p:grpSpPr>
          <a:xfrm>
            <a:off x="726480" y="2519280"/>
            <a:ext cx="7204680" cy="1581120"/>
            <a:chOff x="726480" y="2519280"/>
            <a:chExt cx="7204680" cy="1581120"/>
          </a:xfrm>
        </p:grpSpPr>
        <p:sp>
          <p:nvSpPr>
            <p:cNvPr id="56" name=""/>
            <p:cNvSpPr/>
            <p:nvPr/>
          </p:nvSpPr>
          <p:spPr>
            <a:xfrm>
              <a:off x="727920" y="3338640"/>
              <a:ext cx="1204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A/Egypt/N04526/200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727920" y="3065400"/>
              <a:ext cx="1204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A/Egypt/N03434/200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727920" y="3611520"/>
              <a:ext cx="1204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A/Egypt/N04822/200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727920" y="3884760"/>
              <a:ext cx="1204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A/Egypt/N04979/200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726480" y="2792520"/>
              <a:ext cx="1631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A/duck/Egypt/099-NLQP/2009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2579760" y="3065400"/>
              <a:ext cx="752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15 Apr 200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2579760" y="2792520"/>
              <a:ext cx="610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Jan 200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2580120" y="3611520"/>
              <a:ext cx="7750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25 May 200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2580120" y="3884760"/>
              <a:ext cx="7750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31 May 200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2580120" y="3338640"/>
              <a:ext cx="7750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18 May 200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726480" y="2519280"/>
              <a:ext cx="1721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A/chicken/Egypt/RIMD12-3/200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2579400" y="2519280"/>
              <a:ext cx="62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Nov 200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4426920" y="3065400"/>
              <a:ext cx="243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F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4426920" y="3611520"/>
              <a:ext cx="243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F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4426920" y="3884760"/>
              <a:ext cx="243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F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4415760" y="3338640"/>
              <a:ext cx="266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5002920" y="3065400"/>
              <a:ext cx="293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3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5002560" y="361152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5002560" y="388476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5000400" y="3338640"/>
              <a:ext cx="247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6281640" y="3065400"/>
              <a:ext cx="253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H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6281640" y="2792520"/>
              <a:ext cx="253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 u="sng">
                  <a:solidFill>
                    <a:srgbClr val="000000"/>
                  </a:solidFill>
                  <a:uFillTx/>
                  <a:latin typeface="Arial"/>
                </a:rPr>
                <a:t>H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6281640" y="3611520"/>
              <a:ext cx="253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H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6281640" y="3884760"/>
              <a:ext cx="253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H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6281640" y="3338640"/>
              <a:ext cx="253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H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6281640" y="2519280"/>
              <a:ext cx="253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 u="sng">
                  <a:solidFill>
                    <a:srgbClr val="000000"/>
                  </a:solidFill>
                  <a:uFillTx/>
                  <a:latin typeface="Arial"/>
                </a:rPr>
                <a:t>H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7681680" y="3065400"/>
              <a:ext cx="249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7681680" y="2792520"/>
              <a:ext cx="249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7681680" y="3611520"/>
              <a:ext cx="249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7681680" y="3884760"/>
              <a:ext cx="249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7681680" y="3338640"/>
              <a:ext cx="249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7681680" y="2519280"/>
              <a:ext cx="249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3604680" y="2519280"/>
              <a:ext cx="3848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Bird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3604680" y="2792520"/>
              <a:ext cx="3848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Bird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3604320" y="3065400"/>
              <a:ext cx="526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Huma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3604320" y="3338640"/>
              <a:ext cx="526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Huma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3604320" y="3611520"/>
              <a:ext cx="526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Huma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3604320" y="3884760"/>
              <a:ext cx="526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Huma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4" name=""/>
          <p:cNvSpPr/>
          <p:nvPr/>
        </p:nvSpPr>
        <p:spPr>
          <a:xfrm>
            <a:off x="3605040" y="2112840"/>
            <a:ext cx="406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Hos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507960" y="2476440"/>
            <a:ext cx="809784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507960" y="1889280"/>
            <a:ext cx="809784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507960" y="4413240"/>
            <a:ext cx="809784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507960" y="4149720"/>
            <a:ext cx="80978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4344840" y="2212920"/>
            <a:ext cx="1079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5691240" y="2212920"/>
            <a:ext cx="2914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453960" y="1484280"/>
            <a:ext cx="4767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</a:rPr>
              <a:t>Table S3. Properties of H5N1 influenza viruses in sublineage A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433440" y="4537080"/>
            <a:ext cx="5581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 baseline="30000">
                <a:solidFill>
                  <a:srgbClr val="000000"/>
                </a:solidFill>
                <a:latin typeface="Arial"/>
              </a:rPr>
              <a:t>a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Sequence data from the National Center for Biotechnology Information database in addition to our sequences.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437760" y="5170320"/>
            <a:ext cx="950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 baseline="30000">
                <a:solidFill>
                  <a:srgbClr val="000000"/>
                </a:solidFill>
                <a:latin typeface="Arial"/>
              </a:rPr>
              <a:t>d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H5 numbering.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439920" y="4959360"/>
            <a:ext cx="121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 baseline="30000">
                <a:solidFill>
                  <a:srgbClr val="000000"/>
                </a:solidFill>
                <a:latin typeface="Arial"/>
              </a:rPr>
              <a:t>c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Patient age in years.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6358680" y="1946160"/>
            <a:ext cx="1504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800" spc="-1" strike="noStrike">
                <a:solidFill>
                  <a:srgbClr val="000000"/>
                </a:solidFill>
                <a:latin typeface="Arial"/>
              </a:rPr>
              <a:t>Amino acid at HA residue</a:t>
            </a:r>
            <a:r>
              <a:rPr b="1" lang="ja-JP" sz="800" spc="-1" strike="noStrike" baseline="30000">
                <a:solidFill>
                  <a:srgbClr val="000000"/>
                </a:solidFill>
                <a:latin typeface="Arial"/>
              </a:rPr>
              <a:t>d,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437760" y="4748040"/>
            <a:ext cx="2637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 baseline="30000">
                <a:solidFill>
                  <a:srgbClr val="000000"/>
                </a:solidFill>
                <a:latin typeface="Arial"/>
              </a:rPr>
              <a:t>b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Virus strains are listed in order of collection date.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433800" y="5381640"/>
            <a:ext cx="5334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 baseline="30000">
                <a:solidFill>
                  <a:srgbClr val="000000"/>
                </a:solidFill>
                <a:latin typeface="Arial"/>
              </a:rPr>
              <a:t>e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Key amino acid substitutions for human-type receptor recognition found in avian isolates are underlined.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2-21T05:02:37Z</dcterms:created>
  <dc:creator>nabe</dc:creator>
  <dc:description/>
  <dc:language>en-US</dc:language>
  <cp:lastModifiedBy>nabe</cp:lastModifiedBy>
  <dcterms:modified xsi:type="dcterms:W3CDTF">2011-03-25T08:10:57Z</dcterms:modified>
  <cp:revision>15</cp:revision>
  <dc:subject/>
  <dc:title>スライド 1</dc:title>
</cp:coreProperties>
</file>